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70" r:id="rId2"/>
    <p:sldId id="268" r:id="rId3"/>
    <p:sldId id="271" r:id="rId4"/>
    <p:sldId id="272" r:id="rId5"/>
  </p:sldIdLst>
  <p:sldSz cx="6858000" cy="9906000" type="A4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1pPr>
    <a:lvl2pPr marL="0" marR="0" indent="457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2pPr>
    <a:lvl3pPr marL="0" marR="0" indent="914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3pPr>
    <a:lvl4pPr marL="0" marR="0" indent="1371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4pPr>
    <a:lvl5pPr marL="0" marR="0" indent="18288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5pPr>
    <a:lvl6pPr marL="0" marR="0" indent="22860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6pPr>
    <a:lvl7pPr marL="0" marR="0" indent="2743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7pPr>
    <a:lvl8pPr marL="0" marR="0" indent="3200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8pPr>
    <a:lvl9pPr marL="0" marR="0" indent="3657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76D7EA4-6032-89B6-AF85-A7147D239A13}" name="monti.marco" initials="MM" userId="S::monti.marco@hsr.it::12391de9-a7f0-456f-828a-dcb3bf7b5a30" providerId="AD"/>
  <p188:author id="{687545DA-68F4-0759-D6C4-8971FA20D0BF}" name="Reem Swidah" initials="" userId="S::reem.swidah@manchester.ac.uk::ca39c788-fed4-40cf-a866-cdf607d13e7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/>
    <p:restoredTop sz="94830"/>
  </p:normalViewPr>
  <p:slideViewPr>
    <p:cSldViewPr snapToGrid="0" snapToObjects="1">
      <p:cViewPr>
        <p:scale>
          <a:sx n="241" d="100"/>
          <a:sy n="241" d="100"/>
        </p:scale>
        <p:origin x="752" y="-4192"/>
      </p:cViewPr>
      <p:guideLst/>
    </p:cSldViewPr>
  </p:slideViewPr>
  <p:notesTextViewPr>
    <p:cViewPr>
      <p:scale>
        <a:sx n="25" d="100"/>
        <a:sy n="25" d="100"/>
      </p:scale>
      <p:origin x="0" y="0"/>
    </p:cViewPr>
  </p:notesTextViewPr>
  <p:sorterViewPr>
    <p:cViewPr varScale="1">
      <p:scale>
        <a:sx n="162" d="100"/>
        <a:sy n="16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eemswidah/The%20University%20of%20Manchester%20Dropbox/Reem%20Swidah/Reem%20Cv/Reem%20-%20minmal%20genome%20paper%202024/RS-Method%20paper-2024/sharing%20folder%20For%20easy%20C%20paper/some%20data%20in%2021-5-2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606459976234198E-2"/>
          <c:y val="6.0775004191902911E-2"/>
          <c:w val="0.88424435562277182"/>
          <c:h val="0.6854682954057110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4">
                <a:lumMod val="75000"/>
              </a:schemeClr>
            </a:solidFill>
            <a:ln>
              <a:solidFill>
                <a:schemeClr val="accent3">
                  <a:lumMod val="7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S$61:$S$68</c:f>
                <c:numCache>
                  <c:formatCode>General</c:formatCode>
                  <c:ptCount val="8"/>
                  <c:pt idx="0">
                    <c:v>106.59813962489243</c:v>
                  </c:pt>
                  <c:pt idx="1">
                    <c:v>215.26065317036111</c:v>
                  </c:pt>
                  <c:pt idx="2">
                    <c:v>66.982999008429729</c:v>
                  </c:pt>
                  <c:pt idx="3">
                    <c:v>51.850124147870815</c:v>
                  </c:pt>
                  <c:pt idx="4">
                    <c:v>27.906976744185965</c:v>
                  </c:pt>
                  <c:pt idx="5">
                    <c:v>52.835138709583887</c:v>
                  </c:pt>
                  <c:pt idx="6">
                    <c:v>225.28204544525957</c:v>
                  </c:pt>
                  <c:pt idx="7">
                    <c:v>339.15974603913867</c:v>
                  </c:pt>
                </c:numCache>
              </c:numRef>
            </c:plus>
            <c:minus>
              <c:numRef>
                <c:f>Sheet2!$S$61:$S$68</c:f>
                <c:numCache>
                  <c:formatCode>General</c:formatCode>
                  <c:ptCount val="8"/>
                  <c:pt idx="0">
                    <c:v>106.59813962489243</c:v>
                  </c:pt>
                  <c:pt idx="1">
                    <c:v>215.26065317036111</c:v>
                  </c:pt>
                  <c:pt idx="2">
                    <c:v>66.982999008429729</c:v>
                  </c:pt>
                  <c:pt idx="3">
                    <c:v>51.850124147870815</c:v>
                  </c:pt>
                  <c:pt idx="4">
                    <c:v>27.906976744185965</c:v>
                  </c:pt>
                  <c:pt idx="5">
                    <c:v>52.835138709583887</c:v>
                  </c:pt>
                  <c:pt idx="6">
                    <c:v>225.28204544525957</c:v>
                  </c:pt>
                  <c:pt idx="7">
                    <c:v>339.159746039138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Q$61:$Q$68</c:f>
              <c:strCache>
                <c:ptCount val="8"/>
                <c:pt idx="0">
                  <c:v>S. cerevisiae BY4741
</c:v>
                </c:pt>
                <c:pt idx="1">
                  <c:v>S. cerevisiae BY4741
</c:v>
                </c:pt>
                <c:pt idx="2">
                  <c:v>Sc2.0 synIII synthetic strain 
</c:v>
                </c:pt>
                <c:pt idx="3">
                  <c:v>S. bombicola</c:v>
                </c:pt>
                <c:pt idx="4">
                  <c:v>S. batistae</c:v>
                </c:pt>
                <c:pt idx="5">
                  <c:v>M. bulderi CBS8639 </c:v>
                </c:pt>
                <c:pt idx="6">
                  <c:v>K. naganishi</c:v>
                </c:pt>
                <c:pt idx="7">
                  <c:v>K. aerobia</c:v>
                </c:pt>
              </c:strCache>
            </c:strRef>
          </c:cat>
          <c:val>
            <c:numRef>
              <c:f>Sheet2!$R$61:$R$68</c:f>
              <c:numCache>
                <c:formatCode>General</c:formatCode>
                <c:ptCount val="8"/>
                <c:pt idx="0">
                  <c:v>1361.2903225806451</c:v>
                </c:pt>
                <c:pt idx="1">
                  <c:v>2893</c:v>
                </c:pt>
                <c:pt idx="2">
                  <c:v>781.60919540229895</c:v>
                </c:pt>
                <c:pt idx="3" formatCode="0.00">
                  <c:v>386.66666666666669</c:v>
                </c:pt>
                <c:pt idx="4" formatCode="0.00">
                  <c:v>106.97674418604652</c:v>
                </c:pt>
                <c:pt idx="5" formatCode="0.00">
                  <c:v>84.848484848484858</c:v>
                </c:pt>
                <c:pt idx="6" formatCode="0.00">
                  <c:v>3272</c:v>
                </c:pt>
                <c:pt idx="7" formatCode="0.00">
                  <c:v>1898.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632-D840-907E-0A07976CE2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88631792"/>
        <c:axId val="488633504"/>
      </c:barChart>
      <c:catAx>
        <c:axId val="488631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n-ea"/>
                <a:cs typeface="+mn-cs"/>
              </a:defRPr>
            </a:pPr>
            <a:endParaRPr lang="en-US"/>
          </a:p>
        </c:txPr>
        <c:crossAx val="488633504"/>
        <c:crosses val="autoZero"/>
        <c:auto val="1"/>
        <c:lblAlgn val="ctr"/>
        <c:lblOffset val="100"/>
        <c:noMultiLvlLbl val="0"/>
      </c:catAx>
      <c:valAx>
        <c:axId val="4886335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j-lt"/>
                    <a:ea typeface="+mn-ea"/>
                    <a:cs typeface="+mn-cs"/>
                  </a:defRPr>
                </a:pPr>
                <a:r>
                  <a:rPr lang="en-GB" b="1" dirty="0">
                    <a:latin typeface="+mj-lt"/>
                  </a:rPr>
                  <a:t>Transformation </a:t>
                </a:r>
                <a:r>
                  <a:rPr lang="en-GB" b="1" dirty="0" err="1">
                    <a:latin typeface="+mj-lt"/>
                  </a:rPr>
                  <a:t>effeciency</a:t>
                </a:r>
                <a:r>
                  <a:rPr lang="en-GB" b="1" dirty="0">
                    <a:latin typeface="+mj-lt"/>
                  </a:rPr>
                  <a:t> (CFU/µg of</a:t>
                </a:r>
                <a:r>
                  <a:rPr lang="en-GB" b="1" baseline="0" dirty="0">
                    <a:latin typeface="+mj-lt"/>
                  </a:rPr>
                  <a:t> DNA</a:t>
                </a:r>
                <a:r>
                  <a:rPr lang="en-GB" b="1" dirty="0">
                    <a:latin typeface="+mj-lt"/>
                  </a:rPr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j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86317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Shape 109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0" name="Shape 110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1127806670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defRPr sz="1200">
        <a:latin typeface="+mj-lt"/>
        <a:ea typeface="+mj-ea"/>
        <a:cs typeface="+mj-cs"/>
        <a:sym typeface="Calibri"/>
      </a:defRPr>
    </a:lvl1pPr>
    <a:lvl2pPr indent="228600" defTabSz="457200" latinLnBrk="0">
      <a:defRPr sz="1200">
        <a:latin typeface="+mj-lt"/>
        <a:ea typeface="+mj-ea"/>
        <a:cs typeface="+mj-cs"/>
        <a:sym typeface="Calibri"/>
      </a:defRPr>
    </a:lvl2pPr>
    <a:lvl3pPr indent="457200" defTabSz="457200" latinLnBrk="0">
      <a:defRPr sz="1200">
        <a:latin typeface="+mj-lt"/>
        <a:ea typeface="+mj-ea"/>
        <a:cs typeface="+mj-cs"/>
        <a:sym typeface="Calibri"/>
      </a:defRPr>
    </a:lvl3pPr>
    <a:lvl4pPr indent="685800" defTabSz="457200" latinLnBrk="0">
      <a:defRPr sz="1200">
        <a:latin typeface="+mj-lt"/>
        <a:ea typeface="+mj-ea"/>
        <a:cs typeface="+mj-cs"/>
        <a:sym typeface="Calibri"/>
      </a:defRPr>
    </a:lvl4pPr>
    <a:lvl5pPr indent="914400" defTabSz="457200" latinLnBrk="0">
      <a:defRPr sz="1200">
        <a:latin typeface="+mj-lt"/>
        <a:ea typeface="+mj-ea"/>
        <a:cs typeface="+mj-cs"/>
        <a:sym typeface="Calibri"/>
      </a:defRPr>
    </a:lvl5pPr>
    <a:lvl6pPr indent="1143000" defTabSz="457200" latinLnBrk="0">
      <a:defRPr sz="1200">
        <a:latin typeface="+mj-lt"/>
        <a:ea typeface="+mj-ea"/>
        <a:cs typeface="+mj-cs"/>
        <a:sym typeface="Calibri"/>
      </a:defRPr>
    </a:lvl6pPr>
    <a:lvl7pPr indent="1371600" defTabSz="457200" latinLnBrk="0">
      <a:defRPr sz="1200">
        <a:latin typeface="+mj-lt"/>
        <a:ea typeface="+mj-ea"/>
        <a:cs typeface="+mj-cs"/>
        <a:sym typeface="Calibri"/>
      </a:defRPr>
    </a:lvl7pPr>
    <a:lvl8pPr indent="1600200" defTabSz="457200" latinLnBrk="0">
      <a:defRPr sz="1200">
        <a:latin typeface="+mj-lt"/>
        <a:ea typeface="+mj-ea"/>
        <a:cs typeface="+mj-cs"/>
        <a:sym typeface="Calibri"/>
      </a:defRPr>
    </a:lvl8pPr>
    <a:lvl9pPr indent="1828800" defTabSz="457200" latinLnBrk="0">
      <a:defRPr sz="1200">
        <a:latin typeface="+mj-lt"/>
        <a:ea typeface="+mj-ea"/>
        <a:cs typeface="+mj-cs"/>
        <a:sym typeface="Calibri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05344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342900" y="394404"/>
            <a:ext cx="2256235" cy="167851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2681286" y="394405"/>
            <a:ext cx="3833814" cy="8454499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half" idx="13"/>
          </p:nvPr>
        </p:nvSpPr>
        <p:spPr>
          <a:xfrm>
            <a:off x="342900" y="2072922"/>
            <a:ext cx="2256235" cy="6775982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1344216" y="6934200"/>
            <a:ext cx="4114801" cy="818623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13"/>
          </p:nvPr>
        </p:nvSpPr>
        <p:spPr>
          <a:xfrm>
            <a:off x="1344216" y="885119"/>
            <a:ext cx="4114801" cy="5943601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344216" y="7752822"/>
            <a:ext cx="4114801" cy="1162579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3729037" y="573263"/>
            <a:ext cx="1157289" cy="12208229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257175" y="573263"/>
            <a:ext cx="3357563" cy="12208229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342900" y="396698"/>
            <a:ext cx="6172200" cy="1651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2311400"/>
            <a:ext cx="6172200" cy="653750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251118" y="9310476"/>
            <a:ext cx="263983" cy="2692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5" r:id="rId1"/>
    <p:sldLayoutId id="2147483656" r:id="rId2"/>
    <p:sldLayoutId id="2147483657" r:id="rId3"/>
    <p:sldLayoutId id="2147483658" r:id="rId4"/>
    <p:sldLayoutId id="2147483659" r:id="rId5"/>
  </p:sldLayoutIdLst>
  <p:transition spd="med"/>
  <p:txStyles>
    <p:titleStyle>
      <a:lvl1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titleStyle>
    <p:bodyStyle>
      <a:lvl1pPr marL="342900" marR="0" indent="-3429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783771" marR="0" indent="-326571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1219200" marR="0" indent="-3048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17373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21945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26517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31089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35661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40233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bodyStyle>
    <p:otherStyle>
      <a:lvl1pPr marL="0" marR="0" indent="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31880158-BA63-DFA9-2FF9-AE496AC297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0655973"/>
              </p:ext>
            </p:extLst>
          </p:nvPr>
        </p:nvGraphicFramePr>
        <p:xfrm>
          <a:off x="259770" y="1226127"/>
          <a:ext cx="6291695" cy="5763859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779321">
                  <a:extLst>
                    <a:ext uri="{9D8B030D-6E8A-4147-A177-3AD203B41FA5}">
                      <a16:colId xmlns:a16="http://schemas.microsoft.com/office/drawing/2014/main" val="2240918907"/>
                    </a:ext>
                  </a:extLst>
                </a:gridCol>
                <a:gridCol w="841664">
                  <a:extLst>
                    <a:ext uri="{9D8B030D-6E8A-4147-A177-3AD203B41FA5}">
                      <a16:colId xmlns:a16="http://schemas.microsoft.com/office/drawing/2014/main" val="762156578"/>
                    </a:ext>
                  </a:extLst>
                </a:gridCol>
                <a:gridCol w="436418">
                  <a:extLst>
                    <a:ext uri="{9D8B030D-6E8A-4147-A177-3AD203B41FA5}">
                      <a16:colId xmlns:a16="http://schemas.microsoft.com/office/drawing/2014/main" val="1826052782"/>
                    </a:ext>
                  </a:extLst>
                </a:gridCol>
                <a:gridCol w="338345">
                  <a:extLst>
                    <a:ext uri="{9D8B030D-6E8A-4147-A177-3AD203B41FA5}">
                      <a16:colId xmlns:a16="http://schemas.microsoft.com/office/drawing/2014/main" val="524152552"/>
                    </a:ext>
                  </a:extLst>
                </a:gridCol>
                <a:gridCol w="711137">
                  <a:extLst>
                    <a:ext uri="{9D8B030D-6E8A-4147-A177-3AD203B41FA5}">
                      <a16:colId xmlns:a16="http://schemas.microsoft.com/office/drawing/2014/main" val="2280670833"/>
                    </a:ext>
                  </a:extLst>
                </a:gridCol>
                <a:gridCol w="810490">
                  <a:extLst>
                    <a:ext uri="{9D8B030D-6E8A-4147-A177-3AD203B41FA5}">
                      <a16:colId xmlns:a16="http://schemas.microsoft.com/office/drawing/2014/main" val="1085369731"/>
                    </a:ext>
                  </a:extLst>
                </a:gridCol>
                <a:gridCol w="993860">
                  <a:extLst>
                    <a:ext uri="{9D8B030D-6E8A-4147-A177-3AD203B41FA5}">
                      <a16:colId xmlns:a16="http://schemas.microsoft.com/office/drawing/2014/main" val="3648100221"/>
                    </a:ext>
                  </a:extLst>
                </a:gridCol>
                <a:gridCol w="768256">
                  <a:extLst>
                    <a:ext uri="{9D8B030D-6E8A-4147-A177-3AD203B41FA5}">
                      <a16:colId xmlns:a16="http://schemas.microsoft.com/office/drawing/2014/main" val="1102785761"/>
                    </a:ext>
                  </a:extLst>
                </a:gridCol>
                <a:gridCol w="355318">
                  <a:extLst>
                    <a:ext uri="{9D8B030D-6E8A-4147-A177-3AD203B41FA5}">
                      <a16:colId xmlns:a16="http://schemas.microsoft.com/office/drawing/2014/main" val="1452779121"/>
                    </a:ext>
                  </a:extLst>
                </a:gridCol>
                <a:gridCol w="256886">
                  <a:extLst>
                    <a:ext uri="{9D8B030D-6E8A-4147-A177-3AD203B41FA5}">
                      <a16:colId xmlns:a16="http://schemas.microsoft.com/office/drawing/2014/main" val="1598134416"/>
                    </a:ext>
                  </a:extLst>
                </a:gridCol>
              </a:tblGrid>
              <a:tr h="41739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+mj-lt"/>
                        </a:rPr>
                        <a:t>Name of strain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2532" marR="2532" marT="2532" marB="0" anchor="ctr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+mj-lt"/>
                        </a:rPr>
                        <a:t>Plasmid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2532" marR="2532" marT="2532" marB="0" anchor="ctr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+mj-lt"/>
                        </a:rPr>
                        <a:t>Size </a:t>
                      </a:r>
                      <a:r>
                        <a:rPr lang="en-GB" sz="1000" b="1" u="none" strike="noStrike" dirty="0" err="1">
                          <a:effectLst/>
                          <a:latin typeface="+mj-lt"/>
                        </a:rPr>
                        <a:t>Kb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2532" marR="2532" marT="2532" marB="0" anchor="ctr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+mj-lt"/>
                        </a:rPr>
                        <a:t>Type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2532" marR="2532" marT="2532" marB="0" anchor="ctr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+mj-lt"/>
                        </a:rPr>
                        <a:t>A260/A280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2532" marR="2532" marT="2532" marB="0" anchor="ctr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+mj-lt"/>
                        </a:rPr>
                        <a:t>DNA concentration from yeast (ng/µL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2532" marR="2532" marT="2532" marB="0" anchor="ctr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+mj-lt"/>
                        </a:rPr>
                        <a:t>DNA used for the transformation (ng in 5µL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2532" marR="2532" marT="2532" marB="0" anchor="ctr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+mj-lt"/>
                        </a:rPr>
                        <a:t>Number of colonies for each replicate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2532" marR="2532" marT="2532" marB="0" anchor="ctr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+mj-lt"/>
                        </a:rPr>
                        <a:t>Ave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2532" marR="2532" marT="2532" marB="0" anchor="ctr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+mj-lt"/>
                        </a:rPr>
                        <a:t>SD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2532" marR="2532" marT="2532" marB="0" anchor="ctr"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760168"/>
                  </a:ext>
                </a:extLst>
              </a:tr>
              <a:tr h="16894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S. cerevisiae BY4741</a:t>
                      </a:r>
                      <a:endParaRPr lang="en-GB" sz="1000" b="1" i="1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 err="1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pRS</a:t>
                      </a:r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 415-  </a:t>
                      </a:r>
                      <a:r>
                        <a:rPr lang="en-GB" sz="1050" b="1" u="none" strike="noStrike" dirty="0" err="1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ori</a:t>
                      </a:r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/ARS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6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LCN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.85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31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55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00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133981293"/>
                  </a:ext>
                </a:extLst>
              </a:tr>
              <a:tr h="1689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5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30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11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6.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358178236"/>
                  </a:ext>
                </a:extLst>
              </a:tr>
              <a:tr h="1795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5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03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3595830033"/>
                  </a:ext>
                </a:extLst>
              </a:tr>
              <a:tr h="35900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S. cerevisiae BY4741</a:t>
                      </a:r>
                      <a:endParaRPr lang="en-GB" sz="1000" b="1" i="1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pUDPZB-UI- PAN/ARS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0.3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HCN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.89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30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310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407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3065896807"/>
                  </a:ext>
                </a:extLst>
              </a:tr>
              <a:tr h="1689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310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510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434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66.7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2099129840"/>
                  </a:ext>
                </a:extLst>
              </a:tr>
              <a:tr h="1795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310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38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2910524975"/>
                  </a:ext>
                </a:extLst>
              </a:tr>
              <a:tr h="35900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Sc2.0 </a:t>
                      </a:r>
                      <a:r>
                        <a:rPr lang="en-GB" sz="1000" b="1" i="1" u="none" strike="noStrike" dirty="0" err="1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synIII</a:t>
                      </a:r>
                      <a:r>
                        <a:rPr lang="en-GB" sz="1000" b="1" i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 synthetic strain </a:t>
                      </a:r>
                      <a:endParaRPr lang="en-GB" sz="1000" b="1" i="1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mini-chromosome - ori/ARS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42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LCN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.87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9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4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0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686998614"/>
                  </a:ext>
                </a:extLst>
              </a:tr>
              <a:tr h="1689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4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24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13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9.7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1685310326"/>
                  </a:ext>
                </a:extLst>
              </a:tr>
              <a:tr h="1795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4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11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2400887047"/>
                  </a:ext>
                </a:extLst>
              </a:tr>
              <a:tr h="35900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S. </a:t>
                      </a:r>
                      <a:r>
                        <a:rPr lang="en-GB" sz="1000" b="1" i="1" u="none" strike="noStrike" dirty="0" err="1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bombicola</a:t>
                      </a:r>
                      <a:endParaRPr lang="en-GB" sz="1000" b="1" i="1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pUDPZB-UI -PAN/ARS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uFillTx/>
                          <a:latin typeface="+mn-lt"/>
                          <a:ea typeface="+mn-ea"/>
                          <a:cs typeface="+mn-cs"/>
                          <a:sym typeface="Calibri"/>
                        </a:rPr>
                        <a:t>10.3</a:t>
                      </a:r>
                      <a:endParaRPr lang="en-GB" sz="1050" b="1" i="0" u="none" strike="noStrike" cap="none" spc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uFillTx/>
                        <a:latin typeface="+mn-lt"/>
                        <a:ea typeface="+mn-ea"/>
                        <a:cs typeface="+mn-cs"/>
                        <a:sym typeface="Calibri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HCN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.9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3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75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58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3837694356"/>
                  </a:ext>
                </a:extLst>
              </a:tr>
              <a:tr h="1689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7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69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68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9.1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2930123988"/>
                  </a:ext>
                </a:extLst>
              </a:tr>
              <a:tr h="1795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7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76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4161586322"/>
                  </a:ext>
                </a:extLst>
              </a:tr>
              <a:tr h="35900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S. </a:t>
                      </a:r>
                      <a:r>
                        <a:rPr lang="en-GB" sz="1000" b="1" i="1" u="none" strike="noStrike" dirty="0" err="1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batistae</a:t>
                      </a:r>
                      <a:endParaRPr lang="en-GB" sz="1000" b="1" i="1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pUDPZB-UI -PAN/ARS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uFillTx/>
                          <a:latin typeface="+mn-lt"/>
                          <a:ea typeface="+mn-ea"/>
                          <a:cs typeface="+mn-cs"/>
                          <a:sym typeface="Calibri"/>
                        </a:rPr>
                        <a:t>10.3</a:t>
                      </a:r>
                      <a:endParaRPr lang="en-GB" sz="1050" b="1" i="0" u="none" strike="noStrike" cap="none" spc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uFillTx/>
                        <a:latin typeface="+mn-lt"/>
                        <a:ea typeface="+mn-ea"/>
                        <a:cs typeface="+mn-cs"/>
                        <a:sym typeface="Calibri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HCN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.8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43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1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9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3995868289"/>
                  </a:ext>
                </a:extLst>
              </a:tr>
              <a:tr h="1689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1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7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3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6.0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3791071729"/>
                  </a:ext>
                </a:extLst>
              </a:tr>
              <a:tr h="22065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1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3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1614025867"/>
                  </a:ext>
                </a:extLst>
              </a:tr>
              <a:tr h="35900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M. </a:t>
                      </a:r>
                      <a:r>
                        <a:rPr lang="en-GB" sz="1000" b="1" i="1" u="none" strike="noStrike" dirty="0" err="1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bulderi</a:t>
                      </a:r>
                      <a:r>
                        <a:rPr lang="en-GB" sz="1000" b="1" i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 CBS8639 </a:t>
                      </a:r>
                      <a:endParaRPr lang="en-GB" sz="1000" b="1" i="1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pUDPZB-UI -PAN/ARS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uFillTx/>
                          <a:latin typeface="+mn-lt"/>
                          <a:ea typeface="+mn-ea"/>
                          <a:cs typeface="+mn-cs"/>
                          <a:sym typeface="Calibri"/>
                        </a:rPr>
                        <a:t>10.3</a:t>
                      </a:r>
                      <a:endParaRPr lang="en-GB" sz="1050" b="1" i="0" u="none" strike="noStrike" cap="none" spc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uFillTx/>
                        <a:latin typeface="+mn-lt"/>
                        <a:ea typeface="+mn-ea"/>
                        <a:cs typeface="+mn-cs"/>
                        <a:sym typeface="Calibri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HCN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.87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33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6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8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775391199"/>
                  </a:ext>
                </a:extLst>
              </a:tr>
              <a:tr h="1689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6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4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4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8.7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994919098"/>
                  </a:ext>
                </a:extLst>
              </a:tr>
              <a:tr h="1795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6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0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715073895"/>
                  </a:ext>
                </a:extLst>
              </a:tr>
              <a:tr h="179503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K. </a:t>
                      </a:r>
                      <a:r>
                        <a:rPr lang="en-GB" sz="1000" b="1" i="1" u="none" strike="noStrike" dirty="0" err="1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naganishi</a:t>
                      </a:r>
                      <a:endParaRPr lang="en-GB" sz="1000" b="1" i="1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 err="1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pRS</a:t>
                      </a:r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- PAN/ARS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6.31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HCN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.82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2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402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3122965306"/>
                  </a:ext>
                </a:extLst>
              </a:tr>
              <a:tr h="1689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2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38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409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8.2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1348162619"/>
                  </a:ext>
                </a:extLst>
              </a:tr>
              <a:tr h="1795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2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440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2657494269"/>
                  </a:ext>
                </a:extLst>
              </a:tr>
              <a:tr h="179503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K. aerobia</a:t>
                      </a:r>
                      <a:endParaRPr lang="en-GB" sz="1000" b="1" i="1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 err="1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pRS</a:t>
                      </a:r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- PAN/ARS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6.31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HCN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.86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2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44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2333057419"/>
                  </a:ext>
                </a:extLst>
              </a:tr>
              <a:tr h="1689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2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92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37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42.4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3837265250"/>
                  </a:ext>
                </a:extLst>
              </a:tr>
              <a:tr h="1795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125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276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50" b="1" u="none" strike="noStrike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highlight>
                            <a:srgbClr val="FFFFFF"/>
                          </a:highlight>
                          <a:latin typeface="+mj-lt"/>
                        </a:rPr>
                        <a:t> 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+mj-lt"/>
                      </a:endParaRPr>
                    </a:p>
                  </a:txBody>
                  <a:tcPr marL="2532" marR="2532" marT="2532" marB="0" anchor="ctr"/>
                </a:tc>
                <a:extLst>
                  <a:ext uri="{0D108BD9-81ED-4DB2-BD59-A6C34878D82A}">
                    <a16:rowId xmlns:a16="http://schemas.microsoft.com/office/drawing/2014/main" val="201485519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51DA46D0-8C15-0634-F66C-8C204C35A5F4}"/>
              </a:ext>
            </a:extLst>
          </p:cNvPr>
          <p:cNvSpPr txBox="1"/>
          <p:nvPr/>
        </p:nvSpPr>
        <p:spPr>
          <a:xfrm>
            <a:off x="54252" y="756882"/>
            <a:ext cx="6991125" cy="30777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r>
              <a:rPr lang="en-GB" sz="1400" b="1" dirty="0">
                <a:solidFill>
                  <a:srgbClr val="212121"/>
                </a:solidFill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Table S1 </a:t>
            </a:r>
            <a:r>
              <a:rPr lang="en-GB" sz="1400" dirty="0"/>
              <a:t>The accompanying table summarizes key experimental details </a:t>
            </a:r>
            <a:r>
              <a:rPr lang="en-GB" sz="1400" dirty="0" err="1"/>
              <a:t>forEASY</a:t>
            </a:r>
            <a:r>
              <a:rPr lang="en-GB" sz="1400" dirty="0"/>
              <a:t>-C protocol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cs typeface="Calibri"/>
                <a:sym typeface="Calibri"/>
              </a:rPr>
              <a:t> </a:t>
            </a:r>
            <a:endParaRPr lang="en-US"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D204B8-0012-9A83-B0E2-A42FC9633990}"/>
              </a:ext>
            </a:extLst>
          </p:cNvPr>
          <p:cNvSpPr txBox="1"/>
          <p:nvPr/>
        </p:nvSpPr>
        <p:spPr>
          <a:xfrm>
            <a:off x="1428376" y="348845"/>
            <a:ext cx="3429000" cy="33855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ctr"/>
            <a:r>
              <a:rPr lang="en-GB" sz="1600" b="1" dirty="0">
                <a:effectLst/>
                <a:latin typeface="+mj-lt"/>
              </a:rPr>
              <a:t>Supplementary </a:t>
            </a:r>
            <a:endParaRPr lang="en-US" sz="4400" b="1" dirty="0"/>
          </a:p>
        </p:txBody>
      </p:sp>
    </p:spTree>
    <p:extLst>
      <p:ext uri="{BB962C8B-B14F-4D97-AF65-F5344CB8AC3E}">
        <p14:creationId xmlns:p14="http://schemas.microsoft.com/office/powerpoint/2010/main" val="3442297605"/>
      </p:ext>
    </p:extLst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7ECC921-ECF9-90B4-5C2E-2FAC18F36209}"/>
              </a:ext>
            </a:extLst>
          </p:cNvPr>
          <p:cNvSpPr txBox="1"/>
          <p:nvPr/>
        </p:nvSpPr>
        <p:spPr>
          <a:xfrm>
            <a:off x="1428376" y="348845"/>
            <a:ext cx="3429000" cy="33855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ctr"/>
            <a:r>
              <a:rPr lang="en-GB" sz="1600" b="1" dirty="0">
                <a:effectLst/>
                <a:latin typeface="+mj-lt"/>
              </a:rPr>
              <a:t>Supplementary </a:t>
            </a:r>
            <a:endParaRPr lang="en-US" sz="4400" b="1" dirty="0"/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1AFFE8F7-90FF-43F7-4F6F-CD9071E183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1645452"/>
              </p:ext>
            </p:extLst>
          </p:nvPr>
        </p:nvGraphicFramePr>
        <p:xfrm>
          <a:off x="46759" y="815389"/>
          <a:ext cx="6681355" cy="31099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DD1EFA6-ADC6-4DBF-8A05-42EFF265E1DA}"/>
              </a:ext>
            </a:extLst>
          </p:cNvPr>
          <p:cNvSpPr txBox="1"/>
          <p:nvPr/>
        </p:nvSpPr>
        <p:spPr>
          <a:xfrm>
            <a:off x="108536" y="4831986"/>
            <a:ext cx="6435055" cy="6463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just"/>
            <a:r>
              <a:rPr lang="en-GB" sz="1200" b="1" dirty="0"/>
              <a:t>Figure S1. Bacterial transformation efficiency using the EASY-C protocol to recover plasmids/mini-chromosomes derived from the WT, SYNIII synthetic strain, and non-conventional yeast.</a:t>
            </a:r>
          </a:p>
          <a:p>
            <a:pPr algn="just"/>
            <a:r>
              <a:rPr lang="en-GB" sz="1200" b="1" dirty="0"/>
              <a:t> </a:t>
            </a:r>
            <a:endParaRPr lang="en-GB" sz="1200" dirty="0"/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FD97DC9E-A8BA-1CC6-7105-47850C9397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6502045"/>
              </p:ext>
            </p:extLst>
          </p:nvPr>
        </p:nvGraphicFramePr>
        <p:xfrm>
          <a:off x="514351" y="3621916"/>
          <a:ext cx="6089072" cy="9448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61134">
                  <a:extLst>
                    <a:ext uri="{9D8B030D-6E8A-4147-A177-3AD203B41FA5}">
                      <a16:colId xmlns:a16="http://schemas.microsoft.com/office/drawing/2014/main" val="2003800711"/>
                    </a:ext>
                  </a:extLst>
                </a:gridCol>
                <a:gridCol w="761134">
                  <a:extLst>
                    <a:ext uri="{9D8B030D-6E8A-4147-A177-3AD203B41FA5}">
                      <a16:colId xmlns:a16="http://schemas.microsoft.com/office/drawing/2014/main" val="1677323027"/>
                    </a:ext>
                  </a:extLst>
                </a:gridCol>
                <a:gridCol w="761134">
                  <a:extLst>
                    <a:ext uri="{9D8B030D-6E8A-4147-A177-3AD203B41FA5}">
                      <a16:colId xmlns:a16="http://schemas.microsoft.com/office/drawing/2014/main" val="1696760320"/>
                    </a:ext>
                  </a:extLst>
                </a:gridCol>
                <a:gridCol w="761134">
                  <a:extLst>
                    <a:ext uri="{9D8B030D-6E8A-4147-A177-3AD203B41FA5}">
                      <a16:colId xmlns:a16="http://schemas.microsoft.com/office/drawing/2014/main" val="1007695793"/>
                    </a:ext>
                  </a:extLst>
                </a:gridCol>
                <a:gridCol w="761134">
                  <a:extLst>
                    <a:ext uri="{9D8B030D-6E8A-4147-A177-3AD203B41FA5}">
                      <a16:colId xmlns:a16="http://schemas.microsoft.com/office/drawing/2014/main" val="1081266969"/>
                    </a:ext>
                  </a:extLst>
                </a:gridCol>
                <a:gridCol w="761134">
                  <a:extLst>
                    <a:ext uri="{9D8B030D-6E8A-4147-A177-3AD203B41FA5}">
                      <a16:colId xmlns:a16="http://schemas.microsoft.com/office/drawing/2014/main" val="1586022917"/>
                    </a:ext>
                  </a:extLst>
                </a:gridCol>
                <a:gridCol w="761134">
                  <a:extLst>
                    <a:ext uri="{9D8B030D-6E8A-4147-A177-3AD203B41FA5}">
                      <a16:colId xmlns:a16="http://schemas.microsoft.com/office/drawing/2014/main" val="2674188059"/>
                    </a:ext>
                  </a:extLst>
                </a:gridCol>
                <a:gridCol w="761134">
                  <a:extLst>
                    <a:ext uri="{9D8B030D-6E8A-4147-A177-3AD203B41FA5}">
                      <a16:colId xmlns:a16="http://schemas.microsoft.com/office/drawing/2014/main" val="86992238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000" b="0" i="0" u="none" strike="noStrike" cap="none" spc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pRS-ori</a:t>
                      </a:r>
                      <a:r>
                        <a:rPr lang="en-GB" sz="10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/ARS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cap="none" spc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pUDPZB</a:t>
                      </a:r>
                      <a:r>
                        <a:rPr lang="en-GB" sz="10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-U</a:t>
                      </a: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latin typeface="+mj-lt"/>
                        </a:rPr>
                        <a:t>Mini chr-</a:t>
                      </a:r>
                      <a:r>
                        <a:rPr lang="en-GB" sz="1000" b="0" i="0" u="none" strike="noStrike" cap="none" spc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ori</a:t>
                      </a:r>
                      <a:r>
                        <a:rPr lang="en-GB" sz="10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/ARS</a:t>
                      </a:r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cap="none" spc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pUDPZB</a:t>
                      </a:r>
                      <a:r>
                        <a:rPr lang="en-GB" sz="10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-U</a:t>
                      </a: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cap="none" spc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pUDPZB</a:t>
                      </a:r>
                      <a:r>
                        <a:rPr lang="en-GB" sz="10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-U</a:t>
                      </a: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cap="none" spc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pRS</a:t>
                      </a:r>
                      <a:r>
                        <a:rPr lang="en-GB" sz="10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  -  PAN/ARS</a:t>
                      </a: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cap="none" spc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pRS</a:t>
                      </a:r>
                      <a:r>
                        <a:rPr lang="en-GB" sz="10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  -  PAN/ARS</a:t>
                      </a: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cap="none" spc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pRS</a:t>
                      </a:r>
                      <a:r>
                        <a:rPr lang="en-GB" sz="10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  -  PAN/ARS</a:t>
                      </a: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7426936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0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LCN</a:t>
                      </a:r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latin typeface="+mj-lt"/>
                        </a:rPr>
                        <a:t>HCN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FillTx/>
                          <a:latin typeface="+mj-lt"/>
                          <a:ea typeface="+mn-ea"/>
                          <a:cs typeface="+mn-cs"/>
                          <a:sym typeface="Calibri"/>
                        </a:rPr>
                        <a:t>LCN</a:t>
                      </a:r>
                      <a:endParaRPr lang="en-US" sz="1000" b="0" dirty="0">
                        <a:latin typeface="+mj-lt"/>
                      </a:endParaRP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latin typeface="+mj-lt"/>
                        </a:rPr>
                        <a:t>HCN</a:t>
                      </a: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latin typeface="+mj-lt"/>
                        </a:rPr>
                        <a:t>HCN</a:t>
                      </a: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latin typeface="+mj-lt"/>
                        </a:rPr>
                        <a:t>HCN</a:t>
                      </a: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latin typeface="+mj-lt"/>
                        </a:rPr>
                        <a:t>HCN</a:t>
                      </a: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latin typeface="+mj-lt"/>
                        </a:rPr>
                        <a:t>HCN</a:t>
                      </a:r>
                    </a:p>
                    <a:p>
                      <a:pPr algn="ctr"/>
                      <a:endParaRPr lang="en-US" sz="1000" b="0" dirty="0">
                        <a:latin typeface="+mj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39550239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AB7AF04A-4A54-E2EC-44D0-7BCAA6DC69E9}"/>
              </a:ext>
            </a:extLst>
          </p:cNvPr>
          <p:cNvSpPr txBox="1"/>
          <p:nvPr/>
        </p:nvSpPr>
        <p:spPr>
          <a:xfrm>
            <a:off x="-46759" y="3629846"/>
            <a:ext cx="1143001" cy="26161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r>
              <a:rPr lang="en-GB" sz="1100" b="1" dirty="0"/>
              <a:t>plasmid</a:t>
            </a:r>
            <a:endParaRPr lang="en-US" sz="11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43AF25F-FDB2-859B-DD0B-FE4833969851}"/>
              </a:ext>
            </a:extLst>
          </p:cNvPr>
          <p:cNvSpPr txBox="1"/>
          <p:nvPr/>
        </p:nvSpPr>
        <p:spPr>
          <a:xfrm>
            <a:off x="-46759" y="4136266"/>
            <a:ext cx="1143001" cy="26161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r>
              <a:rPr lang="en-GB" sz="1100" b="1" dirty="0"/>
              <a:t>Type</a:t>
            </a:r>
            <a:endParaRPr lang="en-US" sz="11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B2B0D5B-8200-D3AC-9193-86C0FAD9DD1E}"/>
              </a:ext>
            </a:extLst>
          </p:cNvPr>
          <p:cNvSpPr txBox="1"/>
          <p:nvPr/>
        </p:nvSpPr>
        <p:spPr>
          <a:xfrm>
            <a:off x="905806" y="2139515"/>
            <a:ext cx="380871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Calibri"/>
              </a:rPr>
              <a:t>1361*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FF20985-DBA3-F7E3-D23D-F687247C3E29}"/>
              </a:ext>
            </a:extLst>
          </p:cNvPr>
          <p:cNvSpPr txBox="1"/>
          <p:nvPr/>
        </p:nvSpPr>
        <p:spPr>
          <a:xfrm>
            <a:off x="1645221" y="1270684"/>
            <a:ext cx="323163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Calibri"/>
              </a:rPr>
              <a:t>289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8E5B573-6AF4-C4C8-99AD-3F98E51F06F1}"/>
              </a:ext>
            </a:extLst>
          </p:cNvPr>
          <p:cNvSpPr txBox="1"/>
          <p:nvPr/>
        </p:nvSpPr>
        <p:spPr>
          <a:xfrm>
            <a:off x="2368260" y="2512665"/>
            <a:ext cx="352017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Calibri"/>
              </a:rPr>
              <a:t>781.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7E3E8F2-A6CA-F7EA-F1C6-47A758F752F8}"/>
              </a:ext>
            </a:extLst>
          </p:cNvPr>
          <p:cNvSpPr txBox="1"/>
          <p:nvPr/>
        </p:nvSpPr>
        <p:spPr>
          <a:xfrm>
            <a:off x="3121201" y="2692386"/>
            <a:ext cx="409726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Calibri"/>
              </a:rPr>
              <a:t>7386.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5163CE2-18B4-944D-B410-5EF2160826BE}"/>
              </a:ext>
            </a:extLst>
          </p:cNvPr>
          <p:cNvSpPr txBox="1"/>
          <p:nvPr/>
        </p:nvSpPr>
        <p:spPr>
          <a:xfrm>
            <a:off x="3899080" y="2836461"/>
            <a:ext cx="265455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Calibri"/>
              </a:rPr>
              <a:t>10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951512A-8E8B-F984-8C2F-B0DBE059C20C}"/>
              </a:ext>
            </a:extLst>
          </p:cNvPr>
          <p:cNvSpPr txBox="1"/>
          <p:nvPr/>
        </p:nvSpPr>
        <p:spPr>
          <a:xfrm>
            <a:off x="4595480" y="2843200"/>
            <a:ext cx="294309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Calibri"/>
              </a:rPr>
              <a:t>84.8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E709B31-71AC-03EA-56B1-A715DE6A63DA}"/>
              </a:ext>
            </a:extLst>
          </p:cNvPr>
          <p:cNvSpPr txBox="1"/>
          <p:nvPr/>
        </p:nvSpPr>
        <p:spPr>
          <a:xfrm>
            <a:off x="5308854" y="1055538"/>
            <a:ext cx="323163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Calibri"/>
              </a:rPr>
              <a:t>327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CD74692-458A-A46E-05BA-6560E6E4E575}"/>
              </a:ext>
            </a:extLst>
          </p:cNvPr>
          <p:cNvSpPr txBox="1"/>
          <p:nvPr/>
        </p:nvSpPr>
        <p:spPr>
          <a:xfrm>
            <a:off x="6085508" y="1699572"/>
            <a:ext cx="409726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Calibri"/>
              </a:rPr>
              <a:t>1898.7</a:t>
            </a:r>
          </a:p>
        </p:txBody>
      </p:sp>
    </p:spTree>
    <p:extLst>
      <p:ext uri="{BB962C8B-B14F-4D97-AF65-F5344CB8AC3E}">
        <p14:creationId xmlns:p14="http://schemas.microsoft.com/office/powerpoint/2010/main" val="4178638969"/>
      </p:ext>
    </p:extLst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2FECBBA-D723-6786-0D8D-29FF67E19C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5019524"/>
              </p:ext>
            </p:extLst>
          </p:nvPr>
        </p:nvGraphicFramePr>
        <p:xfrm>
          <a:off x="665475" y="1637571"/>
          <a:ext cx="5527050" cy="271934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709735">
                  <a:extLst>
                    <a:ext uri="{9D8B030D-6E8A-4147-A177-3AD203B41FA5}">
                      <a16:colId xmlns:a16="http://schemas.microsoft.com/office/drawing/2014/main" val="263579458"/>
                    </a:ext>
                  </a:extLst>
                </a:gridCol>
                <a:gridCol w="2737970">
                  <a:extLst>
                    <a:ext uri="{9D8B030D-6E8A-4147-A177-3AD203B41FA5}">
                      <a16:colId xmlns:a16="http://schemas.microsoft.com/office/drawing/2014/main" val="813442669"/>
                    </a:ext>
                  </a:extLst>
                </a:gridCol>
                <a:gridCol w="1079345">
                  <a:extLst>
                    <a:ext uri="{9D8B030D-6E8A-4147-A177-3AD203B41FA5}">
                      <a16:colId xmlns:a16="http://schemas.microsoft.com/office/drawing/2014/main" val="4128693011"/>
                    </a:ext>
                  </a:extLst>
                </a:gridCol>
              </a:tblGrid>
              <a:tr h="35877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kern="0" dirty="0">
                          <a:effectLst/>
                        </a:rPr>
                        <a:t>Protocol / Reagent</a:t>
                      </a:r>
                      <a:endParaRPr lang="en-GB" sz="11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kern="0" dirty="0">
                          <a:effectLst/>
                        </a:rPr>
                        <a:t>Cost details</a:t>
                      </a:r>
                      <a:endParaRPr lang="en-GB" sz="11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kern="0" dirty="0">
                          <a:effectLst/>
                        </a:rPr>
                        <a:t>Price/ Prep</a:t>
                      </a:r>
                      <a:endParaRPr lang="en-GB" sz="11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69887264"/>
                  </a:ext>
                </a:extLst>
              </a:tr>
              <a:tr h="35877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>
                          <a:effectLst/>
                        </a:rPr>
                        <a:t>Zymo Yeast Plasmid Miniprep Kit</a:t>
                      </a:r>
                      <a:endParaRPr lang="en-GB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>
                          <a:effectLst/>
                        </a:rPr>
                        <a:t>£144 for 100 preparations</a:t>
                      </a:r>
                      <a:endParaRPr lang="en-GB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effectLst/>
                        </a:rPr>
                        <a:t>£1.44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02560749"/>
                  </a:ext>
                </a:extLst>
              </a:tr>
              <a:tr h="35877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>
                          <a:effectLst/>
                        </a:rPr>
                        <a:t>Lyticase</a:t>
                      </a:r>
                      <a:endParaRPr lang="en-GB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>
                          <a:effectLst/>
                        </a:rPr>
                        <a:t>~£70 per 25,000 units; 100 units per prep → ~£0.28 each</a:t>
                      </a:r>
                      <a:endParaRPr lang="en-GB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>
                          <a:effectLst/>
                        </a:rPr>
                        <a:t>£0.28</a:t>
                      </a:r>
                      <a:endParaRPr lang="en-GB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63358799"/>
                  </a:ext>
                </a:extLst>
              </a:tr>
              <a:tr h="72517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>
                          <a:effectLst/>
                        </a:rPr>
                        <a:t>Qiagen plasmid prep (adapted for yeast)</a:t>
                      </a:r>
                      <a:endParaRPr lang="en-GB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>
                          <a:effectLst/>
                        </a:rPr>
                        <a:t>Qiagen kit: £160 for buffer + 100 columns; additional 200 columns purchased separately (£46). Total: £206 for 300 preps → ~£0.69 each</a:t>
                      </a:r>
                      <a:endParaRPr lang="en-GB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effectLst/>
                        </a:rPr>
                        <a:t>£0.69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7273632"/>
                  </a:ext>
                </a:extLst>
              </a:tr>
              <a:tr h="47348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err="1"/>
                        <a:t>NucleoBond</a:t>
                      </a:r>
                      <a:r>
                        <a:rPr lang="en-GB" sz="1100" dirty="0"/>
                        <a:t>™ HMW DNA Kit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/>
                        <a:t>£220 for 20 preps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/>
                        <a:t>£22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35123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effectLst/>
                        </a:rPr>
                        <a:t>Easy-C protocol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>
                          <a:effectLst/>
                        </a:rPr>
                        <a:t>Qiagen column + buffer system combined with lyticase digestion</a:t>
                      </a:r>
                      <a:endParaRPr lang="en-GB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effectLst/>
                        </a:rPr>
                        <a:t>£0.96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36401302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0CDBCE3-70F6-F39A-A33B-F7F4EEB3FD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0046519"/>
              </p:ext>
            </p:extLst>
          </p:nvPr>
        </p:nvGraphicFramePr>
        <p:xfrm>
          <a:off x="665475" y="5210703"/>
          <a:ext cx="5527050" cy="134743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754340">
                  <a:extLst>
                    <a:ext uri="{9D8B030D-6E8A-4147-A177-3AD203B41FA5}">
                      <a16:colId xmlns:a16="http://schemas.microsoft.com/office/drawing/2014/main" val="730376059"/>
                    </a:ext>
                  </a:extLst>
                </a:gridCol>
                <a:gridCol w="2653990">
                  <a:extLst>
                    <a:ext uri="{9D8B030D-6E8A-4147-A177-3AD203B41FA5}">
                      <a16:colId xmlns:a16="http://schemas.microsoft.com/office/drawing/2014/main" val="634846629"/>
                    </a:ext>
                  </a:extLst>
                </a:gridCol>
                <a:gridCol w="1118720">
                  <a:extLst>
                    <a:ext uri="{9D8B030D-6E8A-4147-A177-3AD203B41FA5}">
                      <a16:colId xmlns:a16="http://schemas.microsoft.com/office/drawing/2014/main" val="4095150921"/>
                    </a:ext>
                  </a:extLst>
                </a:gridCol>
              </a:tblGrid>
              <a:tr h="30095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kern="0" dirty="0">
                          <a:effectLst/>
                        </a:rPr>
                        <a:t>Sequencing Method</a:t>
                      </a:r>
                      <a:endParaRPr lang="en-GB" sz="11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kern="0" dirty="0">
                          <a:effectLst/>
                        </a:rPr>
                        <a:t>Cost details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kern="0" dirty="0">
                          <a:effectLst/>
                        </a:rPr>
                        <a:t>Price / Prep</a:t>
                      </a:r>
                      <a:endParaRPr lang="en-GB" sz="11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3964977"/>
                  </a:ext>
                </a:extLst>
              </a:tr>
              <a:tr h="35433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 err="1">
                          <a:effectLst/>
                        </a:rPr>
                        <a:t>Plasmidsaurus</a:t>
                      </a:r>
                      <a:r>
                        <a:rPr lang="en-GB" sz="1100" kern="0" dirty="0">
                          <a:effectLst/>
                        </a:rPr>
                        <a:t> long-read sequencing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effectLst/>
                        </a:rPr>
                        <a:t>Small plasmids ~£15</a:t>
                      </a:r>
                      <a:endParaRPr lang="en-GB" sz="1100" kern="100" dirty="0">
                        <a:effectLst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effectLst/>
                        </a:rPr>
                        <a:t> large plasmids ~£30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>
                          <a:effectLst/>
                        </a:rPr>
                        <a:t>£15–£30</a:t>
                      </a:r>
                      <a:endParaRPr lang="en-GB" sz="11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20511874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effectLst/>
                        </a:rPr>
                        <a:t>Oxford Nanopore (in-lab run)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effectLst/>
                        </a:rPr>
                        <a:t>Cost per run in </a:t>
                      </a:r>
                      <a:r>
                        <a:rPr lang="en-GB" sz="1100" dirty="0"/>
                        <a:t>n a multiplexed run, depending on reagent/consumables overhead and sample prep needs .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effectLst/>
                        </a:rPr>
                        <a:t>£80–£100 </a:t>
                      </a:r>
                      <a:endParaRPr lang="en-GB" sz="11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77505759"/>
                  </a:ext>
                </a:extLst>
              </a:tr>
            </a:tbl>
          </a:graphicData>
        </a:graphic>
      </p:graphicFrame>
      <p:sp>
        <p:nvSpPr>
          <p:cNvPr id="4" name="Rectangle 1">
            <a:extLst>
              <a:ext uri="{FF2B5EF4-FFF2-40B4-BE49-F238E27FC236}">
                <a16:creationId xmlns:a16="http://schemas.microsoft.com/office/drawing/2014/main" id="{BAAA35CD-D278-3A74-E0CB-5D128F10FB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338" y="4678824"/>
            <a:ext cx="2127505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2. Nanopore Sequencing Costs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B26C589-7FA8-6EBD-10E7-1C0D22DF51FC}"/>
              </a:ext>
            </a:extLst>
          </p:cNvPr>
          <p:cNvSpPr txBox="1"/>
          <p:nvPr/>
        </p:nvSpPr>
        <p:spPr>
          <a:xfrm>
            <a:off x="414338" y="888178"/>
            <a:ext cx="5645305" cy="276999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sz="1200" b="1" dirty="0">
                <a:solidFill>
                  <a:srgbClr val="212121"/>
                </a:solidFill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Table S2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.  Cost Comparison: Yeast Plasmid Extraction and Long-Read Sequencing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B7F313-A53C-171A-661F-6979984F1443}"/>
              </a:ext>
            </a:extLst>
          </p:cNvPr>
          <p:cNvSpPr txBox="1"/>
          <p:nvPr/>
        </p:nvSpPr>
        <p:spPr>
          <a:xfrm>
            <a:off x="414338" y="1254387"/>
            <a:ext cx="3429000" cy="276999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1. Extraction Costs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4E843E5-D1CC-3E83-375C-E6DE33B4D031}"/>
              </a:ext>
            </a:extLst>
          </p:cNvPr>
          <p:cNvSpPr txBox="1"/>
          <p:nvPr/>
        </p:nvSpPr>
        <p:spPr>
          <a:xfrm>
            <a:off x="1428376" y="348845"/>
            <a:ext cx="3429000" cy="33855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ctr"/>
            <a:r>
              <a:rPr lang="en-GB" sz="1600" b="1" dirty="0">
                <a:effectLst/>
                <a:latin typeface="+mj-lt"/>
              </a:rPr>
              <a:t>Supplementary </a:t>
            </a:r>
            <a:endParaRPr lang="en-US" sz="4400" b="1" dirty="0"/>
          </a:p>
        </p:txBody>
      </p:sp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9A54495E-C03A-F7C9-96A3-B1727F26C4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6668159"/>
              </p:ext>
            </p:extLst>
          </p:nvPr>
        </p:nvGraphicFramePr>
        <p:xfrm>
          <a:off x="665475" y="7177793"/>
          <a:ext cx="5527050" cy="195725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523543">
                  <a:extLst>
                    <a:ext uri="{9D8B030D-6E8A-4147-A177-3AD203B41FA5}">
                      <a16:colId xmlns:a16="http://schemas.microsoft.com/office/drawing/2014/main" val="3508989490"/>
                    </a:ext>
                  </a:extLst>
                </a:gridCol>
                <a:gridCol w="2884787">
                  <a:extLst>
                    <a:ext uri="{9D8B030D-6E8A-4147-A177-3AD203B41FA5}">
                      <a16:colId xmlns:a16="http://schemas.microsoft.com/office/drawing/2014/main" val="1348035295"/>
                    </a:ext>
                  </a:extLst>
                </a:gridCol>
                <a:gridCol w="1118720">
                  <a:extLst>
                    <a:ext uri="{9D8B030D-6E8A-4147-A177-3AD203B41FA5}">
                      <a16:colId xmlns:a16="http://schemas.microsoft.com/office/drawing/2014/main" val="2633429885"/>
                    </a:ext>
                  </a:extLst>
                </a:gridCol>
              </a:tblGrid>
              <a:tr h="322134"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ethod 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kern="0" dirty="0">
                          <a:effectLst/>
                        </a:rPr>
                        <a:t>Cost details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kern="0" dirty="0">
                          <a:effectLst/>
                        </a:rPr>
                        <a:t>Price / Prep</a:t>
                      </a:r>
                      <a:endParaRPr lang="en-GB" sz="11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31369401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Standard method</a:t>
                      </a: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100" b="0" kern="0" dirty="0">
                          <a:effectLst/>
                        </a:rPr>
                        <a:t>(in-lab run)</a:t>
                      </a:r>
                      <a:endParaRPr lang="en-GB" sz="1100" b="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err="1"/>
                        <a:t>NucleoBond</a:t>
                      </a:r>
                      <a:r>
                        <a:rPr lang="en-GB" sz="1100" dirty="0"/>
                        <a:t>™ extraction + Oxford Nanopore (in-lab run)</a:t>
                      </a:r>
                      <a:endParaRPr lang="en-GB" sz="1100" kern="100" dirty="0">
                        <a:effectLst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kern="0" dirty="0">
                          <a:effectLst/>
                        </a:rPr>
                        <a:t>£</a:t>
                      </a:r>
                      <a:r>
                        <a:rPr lang="en-GB" sz="1100" kern="100" dirty="0">
                          <a:effectLst/>
                        </a:rPr>
                        <a:t>102-</a:t>
                      </a:r>
                      <a:r>
                        <a:rPr lang="en-GB" sz="1100" kern="0" dirty="0">
                          <a:effectLst/>
                        </a:rPr>
                        <a:t>£</a:t>
                      </a:r>
                      <a:r>
                        <a:rPr lang="en-GB" sz="1100" kern="100" dirty="0">
                          <a:effectLst/>
                        </a:rPr>
                        <a:t>122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92311687"/>
                  </a:ext>
                </a:extLst>
              </a:tr>
              <a:tr h="177165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kern="0" dirty="0">
                          <a:effectLst/>
                        </a:rPr>
                        <a:t>Easy-C (total)</a:t>
                      </a:r>
                      <a:endParaRPr lang="en-GB" sz="11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kern="0" dirty="0">
                          <a:effectLst/>
                        </a:rPr>
                        <a:t>Easy-C protocol for </a:t>
                      </a:r>
                      <a:r>
                        <a:rPr lang="en-GB" sz="1100" kern="100" dirty="0">
                          <a:effectLst/>
                          <a:latin typeface="Aptos" panose="020B000402020202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100" dirty="0"/>
                        <a:t>extraction + long-read sequencing via </a:t>
                      </a:r>
                      <a:r>
                        <a:rPr lang="en-GB" sz="1100" dirty="0" err="1"/>
                        <a:t>Plasmidsaurus</a:t>
                      </a:r>
                      <a:r>
                        <a:rPr lang="en-GB" sz="1100" dirty="0"/>
                        <a:t>:</a:t>
                      </a:r>
                    </a:p>
                    <a:p>
                      <a:pPr marL="171450" marR="0" lvl="0" indent="-171450" algn="l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100" dirty="0"/>
                        <a:t> </a:t>
                      </a:r>
                      <a:r>
                        <a:rPr lang="en-GB" sz="1100" kern="0" dirty="0">
                          <a:effectLst/>
                        </a:rPr>
                        <a:t>Small plasmids </a:t>
                      </a:r>
                    </a:p>
                    <a:p>
                      <a:pPr marL="171450" marR="0" lvl="0" indent="-171450" algn="l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100" kern="0" dirty="0">
                          <a:effectLst/>
                        </a:rPr>
                        <a:t>Large plasmids/ artificial mini-chromosome 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endParaRPr lang="en-GB" sz="1100" kern="0" dirty="0">
                        <a:effectLst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100" kern="0" dirty="0">
                          <a:effectLst/>
                        </a:rPr>
                        <a:t>~£16</a:t>
                      </a: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kern="0" dirty="0">
                          <a:effectLst/>
                        </a:rPr>
                        <a:t>~£31</a:t>
                      </a:r>
                      <a:endParaRPr lang="en-GB" sz="1100" kern="100" dirty="0">
                        <a:effectLst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8031730"/>
                  </a:ext>
                </a:extLst>
              </a:tr>
            </a:tbl>
          </a:graphicData>
        </a:graphic>
      </p:graphicFrame>
      <p:sp>
        <p:nvSpPr>
          <p:cNvPr id="17" name="Rectangle 1">
            <a:extLst>
              <a:ext uri="{FF2B5EF4-FFF2-40B4-BE49-F238E27FC236}">
                <a16:creationId xmlns:a16="http://schemas.microsoft.com/office/drawing/2014/main" id="{0D062148-9ECF-1088-C76E-52B5DAA398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338" y="6716128"/>
            <a:ext cx="5149167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3. Overall cost: </a:t>
            </a:r>
            <a:r>
              <a:rPr kumimoji="0" lang="en-US" alt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plasmid /mini-chromosome </a:t>
            </a:r>
            <a:r>
              <a:rPr lang="en-GB" sz="1200" kern="0" dirty="0">
                <a:effectLst/>
              </a:rPr>
              <a:t>extraction + long-read sequencing </a:t>
            </a:r>
            <a:r>
              <a:rPr kumimoji="0" lang="en-US" alt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en-US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4129091075"/>
      </p:ext>
    </p:extLst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9BC383A3-36CF-EAE2-29F4-36EDE5184A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7547746"/>
              </p:ext>
            </p:extLst>
          </p:nvPr>
        </p:nvGraphicFramePr>
        <p:xfrm>
          <a:off x="342900" y="1306063"/>
          <a:ext cx="6172200" cy="236728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896866">
                  <a:extLst>
                    <a:ext uri="{9D8B030D-6E8A-4147-A177-3AD203B41FA5}">
                      <a16:colId xmlns:a16="http://schemas.microsoft.com/office/drawing/2014/main" val="4021883726"/>
                    </a:ext>
                  </a:extLst>
                </a:gridCol>
                <a:gridCol w="1189234">
                  <a:extLst>
                    <a:ext uri="{9D8B030D-6E8A-4147-A177-3AD203B41FA5}">
                      <a16:colId xmlns:a16="http://schemas.microsoft.com/office/drawing/2014/main" val="2964343026"/>
                    </a:ext>
                  </a:extLst>
                </a:gridCol>
                <a:gridCol w="1543050">
                  <a:extLst>
                    <a:ext uri="{9D8B030D-6E8A-4147-A177-3AD203B41FA5}">
                      <a16:colId xmlns:a16="http://schemas.microsoft.com/office/drawing/2014/main" val="615775865"/>
                    </a:ext>
                  </a:extLst>
                </a:gridCol>
                <a:gridCol w="1543050">
                  <a:extLst>
                    <a:ext uri="{9D8B030D-6E8A-4147-A177-3AD203B41FA5}">
                      <a16:colId xmlns:a16="http://schemas.microsoft.com/office/drawing/2014/main" val="278025018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0" dirty="0">
                          <a:effectLst/>
                          <a:latin typeface="+mj-ea"/>
                          <a:ea typeface="+mj-ea"/>
                        </a:rPr>
                        <a:t>Reagent</a:t>
                      </a:r>
                      <a:endParaRPr lang="en-GB" sz="1200" b="1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0" dirty="0">
                          <a:effectLst/>
                          <a:latin typeface="+mj-ea"/>
                          <a:ea typeface="+mj-ea"/>
                        </a:rPr>
                        <a:t>Catalogue No.</a:t>
                      </a:r>
                      <a:endParaRPr lang="en-GB" sz="1200" b="1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0" dirty="0">
                          <a:effectLst/>
                          <a:latin typeface="+mj-ea"/>
                          <a:ea typeface="+mj-ea"/>
                        </a:rPr>
                        <a:t>Price (per kit)</a:t>
                      </a:r>
                      <a:endParaRPr lang="en-GB" sz="1200" b="1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0" dirty="0">
                          <a:effectLst/>
                          <a:latin typeface="+mj-ea"/>
                          <a:ea typeface="+mj-ea"/>
                        </a:rPr>
                        <a:t>Cost per sequencing run / genome</a:t>
                      </a:r>
                      <a:endParaRPr lang="en-GB" sz="1200" b="1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extLst>
                  <a:ext uri="{0D108BD9-81ED-4DB2-BD59-A6C34878D82A}">
                    <a16:rowId xmlns:a16="http://schemas.microsoft.com/office/drawing/2014/main" val="26765322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SQK-LSK109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—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£485.00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£80.83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extLst>
                  <a:ext uri="{0D108BD9-81ED-4DB2-BD59-A6C34878D82A}">
                    <a16:rowId xmlns:a16="http://schemas.microsoft.com/office/drawing/2014/main" val="3006698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+mj-ea"/>
                          <a:ea typeface="+mj-ea"/>
                        </a:rPr>
                        <a:t>EXP-NBD104</a:t>
                      </a:r>
                      <a:endParaRPr lang="en-GB" sz="1200" kern="10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—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£235.00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+mj-ea"/>
                          <a:ea typeface="+mj-ea"/>
                        </a:rPr>
                        <a:t>£39.17</a:t>
                      </a:r>
                      <a:endParaRPr lang="en-GB" sz="1200" kern="10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extLst>
                  <a:ext uri="{0D108BD9-81ED-4DB2-BD59-A6C34878D82A}">
                    <a16:rowId xmlns:a16="http://schemas.microsoft.com/office/drawing/2014/main" val="568017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+mj-ea"/>
                          <a:ea typeface="+mj-ea"/>
                        </a:rPr>
                        <a:t>EXP-NBD114</a:t>
                      </a:r>
                      <a:endParaRPr lang="en-GB" sz="1200" kern="10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—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£235.00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+mj-ea"/>
                          <a:ea typeface="+mj-ea"/>
                        </a:rPr>
                        <a:t>£39.17</a:t>
                      </a:r>
                      <a:endParaRPr lang="en-GB" sz="1200" kern="10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extLst>
                  <a:ext uri="{0D108BD9-81ED-4DB2-BD59-A6C34878D82A}">
                    <a16:rowId xmlns:a16="http://schemas.microsoft.com/office/drawing/2014/main" val="40366664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+mj-ea"/>
                          <a:ea typeface="+mj-ea"/>
                        </a:rPr>
                        <a:t>NEBNext® Ultra™ II End Repair/dA-Tailing Module</a:t>
                      </a:r>
                      <a:endParaRPr lang="en-GB" sz="1200" kern="10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E7546L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£595.20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+mj-ea"/>
                          <a:ea typeface="+mj-ea"/>
                        </a:rPr>
                        <a:t>£148.80</a:t>
                      </a:r>
                      <a:endParaRPr lang="en-GB" sz="1200" kern="10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extLst>
                  <a:ext uri="{0D108BD9-81ED-4DB2-BD59-A6C34878D82A}">
                    <a16:rowId xmlns:a16="http://schemas.microsoft.com/office/drawing/2014/main" val="30479512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+mj-ea"/>
                          <a:ea typeface="+mj-ea"/>
                        </a:rPr>
                        <a:t>NEBNext® FFPE DNA Repair Mix</a:t>
                      </a:r>
                      <a:endParaRPr lang="en-GB" sz="1200" kern="10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M6630L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£444.80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+mj-ea"/>
                          <a:ea typeface="+mj-ea"/>
                        </a:rPr>
                        <a:t>£111.20</a:t>
                      </a:r>
                      <a:endParaRPr lang="en-GB" sz="1200" kern="10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extLst>
                  <a:ext uri="{0D108BD9-81ED-4DB2-BD59-A6C34878D82A}">
                    <a16:rowId xmlns:a16="http://schemas.microsoft.com/office/drawing/2014/main" val="22833649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+mj-ea"/>
                          <a:ea typeface="+mj-ea"/>
                        </a:rPr>
                        <a:t>AMPure XP Magnetic Beads</a:t>
                      </a:r>
                      <a:endParaRPr lang="en-GB" sz="1200" kern="10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A63880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£200.00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+mj-ea"/>
                          <a:ea typeface="+mj-ea"/>
                        </a:rPr>
                        <a:t>£100.00</a:t>
                      </a:r>
                      <a:endParaRPr lang="en-GB" sz="1200" kern="10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extLst>
                  <a:ext uri="{0D108BD9-81ED-4DB2-BD59-A6C34878D82A}">
                    <a16:rowId xmlns:a16="http://schemas.microsoft.com/office/drawing/2014/main" val="40594745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+mj-ea"/>
                          <a:ea typeface="+mj-ea"/>
                        </a:rPr>
                        <a:t>FLO-MIN106D (Flow Cell)</a:t>
                      </a:r>
                      <a:endParaRPr lang="en-GB" sz="1200" kern="10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—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£7,620.00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 dirty="0">
                          <a:effectLst/>
                          <a:latin typeface="+mj-ea"/>
                          <a:ea typeface="+mj-ea"/>
                        </a:rPr>
                        <a:t>£635.00</a:t>
                      </a:r>
                      <a:endParaRPr lang="en-GB" sz="1200" kern="100" dirty="0">
                        <a:effectLst/>
                        <a:latin typeface="+mj-ea"/>
                        <a:ea typeface="+mj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/>
                </a:tc>
                <a:extLst>
                  <a:ext uri="{0D108BD9-81ED-4DB2-BD59-A6C34878D82A}">
                    <a16:rowId xmlns:a16="http://schemas.microsoft.com/office/drawing/2014/main" val="2325388299"/>
                  </a:ext>
                </a:extLst>
              </a:tr>
            </a:tbl>
          </a:graphicData>
        </a:graphic>
      </p:graphicFrame>
      <p:sp>
        <p:nvSpPr>
          <p:cNvPr id="8" name="Rectangle 1">
            <a:extLst>
              <a:ext uri="{FF2B5EF4-FFF2-40B4-BE49-F238E27FC236}">
                <a16:creationId xmlns:a16="http://schemas.microsoft.com/office/drawing/2014/main" id="{38BA537D-FB2A-051A-3757-A4694869F1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756" y="752065"/>
            <a:ext cx="5787162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sz="1200" b="1" dirty="0">
                <a:solidFill>
                  <a:srgbClr val="212121"/>
                </a:solidFill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Table S3 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ptos" panose="020B00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Price for one nanopore sequencing run and cost per genome sequenced</a:t>
            </a:r>
            <a:endParaRPr kumimoji="0" lang="en-US" altLang="en-US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3BE4F2-0D07-A61E-C0AC-607DA7B1AB05}"/>
              </a:ext>
            </a:extLst>
          </p:cNvPr>
          <p:cNvSpPr txBox="1"/>
          <p:nvPr/>
        </p:nvSpPr>
        <p:spPr>
          <a:xfrm>
            <a:off x="1428376" y="348845"/>
            <a:ext cx="3429000" cy="33855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ctr"/>
            <a:r>
              <a:rPr lang="en-GB" sz="1600" b="1" dirty="0">
                <a:effectLst/>
                <a:latin typeface="+mj-lt"/>
              </a:rPr>
              <a:t>Supplementary </a:t>
            </a:r>
            <a:endParaRPr lang="en-US" sz="4400" b="1" dirty="0"/>
          </a:p>
        </p:txBody>
      </p:sp>
    </p:spTree>
    <p:extLst>
      <p:ext uri="{BB962C8B-B14F-4D97-AF65-F5344CB8AC3E}">
        <p14:creationId xmlns:p14="http://schemas.microsoft.com/office/powerpoint/2010/main" val="3440933453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02</TotalTime>
  <Words>663</Words>
  <Application>Microsoft Macintosh PowerPoint</Application>
  <PresentationFormat>A4 Paper (210x297 mm)</PresentationFormat>
  <Paragraphs>267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Reem Swidah</cp:lastModifiedBy>
  <cp:revision>262</cp:revision>
  <dcterms:modified xsi:type="dcterms:W3CDTF">2026-01-16T12:36:09Z</dcterms:modified>
</cp:coreProperties>
</file>